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124A84C-8831-5595-30EB-6968EEE5D9C6}" v="331" dt="2024-05-16T19:59:53.797"/>
    <p1510:client id="{A0F008C2-461A-A9F4-E4E5-4EB992C883D1}" v="4" dt="2024-05-15T17:23:37.92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2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8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00D2309-845E-D210-B282-1BF26EC0AFA0}"/>
              </a:ext>
            </a:extLst>
          </p:cNvPr>
          <p:cNvGrpSpPr/>
          <p:nvPr/>
        </p:nvGrpSpPr>
        <p:grpSpPr>
          <a:xfrm>
            <a:off x="31314" y="158727"/>
            <a:ext cx="2722159" cy="3093733"/>
            <a:chOff x="594985" y="565823"/>
            <a:chExt cx="2722159" cy="3093733"/>
          </a:xfrm>
        </p:grpSpPr>
        <p:pic>
          <p:nvPicPr>
            <p:cNvPr id="4" name="Picture 3" descr="A white rectangular object with black dots&#10;&#10;Description automatically generated">
              <a:extLst>
                <a:ext uri="{FF2B5EF4-FFF2-40B4-BE49-F238E27FC236}">
                  <a16:creationId xmlns:a16="http://schemas.microsoft.com/office/drawing/2014/main" id="{551783ED-480D-0883-1296-A7CF2D49F1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-1058" t="14723" r="57307" b="23827"/>
            <a:stretch/>
          </p:blipFill>
          <p:spPr>
            <a:xfrm>
              <a:off x="1075148" y="1427924"/>
              <a:ext cx="1972727" cy="221492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807045E-6606-FEF8-5E0F-80CE2A9ACFC7}"/>
                </a:ext>
              </a:extLst>
            </p:cNvPr>
            <p:cNvSpPr txBox="1"/>
            <p:nvPr/>
          </p:nvSpPr>
          <p:spPr>
            <a:xfrm rot="18720000">
              <a:off x="1534649" y="1005468"/>
              <a:ext cx="10234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R1276Q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AA4354E-F74D-AE32-59FD-E7BF070422CA}"/>
                </a:ext>
              </a:extLst>
            </p:cNvPr>
            <p:cNvSpPr txBox="1"/>
            <p:nvPr/>
          </p:nvSpPr>
          <p:spPr>
            <a:xfrm rot="18827009">
              <a:off x="1238834" y="1007282"/>
              <a:ext cx="10234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Knock Out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807423C-32CC-918D-C509-A773EC8BB5AC}"/>
                </a:ext>
              </a:extLst>
            </p:cNvPr>
            <p:cNvSpPr txBox="1"/>
            <p:nvPr/>
          </p:nvSpPr>
          <p:spPr>
            <a:xfrm rot="18966357">
              <a:off x="1822775" y="1020022"/>
              <a:ext cx="10234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HEK 293 +/+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94403B8-AD9E-CB82-6766-A229C72364A1}"/>
                </a:ext>
              </a:extLst>
            </p:cNvPr>
            <p:cNvSpPr txBox="1"/>
            <p:nvPr/>
          </p:nvSpPr>
          <p:spPr>
            <a:xfrm rot="18821298">
              <a:off x="2075265" y="996231"/>
              <a:ext cx="11124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Empty Vector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E27C647-A863-6D70-CC54-FF952409900A}"/>
                </a:ext>
              </a:extLst>
            </p:cNvPr>
            <p:cNvSpPr txBox="1"/>
            <p:nvPr/>
          </p:nvSpPr>
          <p:spPr>
            <a:xfrm rot="18821298">
              <a:off x="2349769" y="983551"/>
              <a:ext cx="11124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Wild Type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3CFFCB4-F10B-2463-1F51-56341BAA9B3E}"/>
                </a:ext>
              </a:extLst>
            </p:cNvPr>
            <p:cNvSpPr txBox="1"/>
            <p:nvPr/>
          </p:nvSpPr>
          <p:spPr>
            <a:xfrm rot="18821298">
              <a:off x="2622417" y="1001664"/>
              <a:ext cx="11124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Del Exon 24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EEFEA06-EC95-B04E-E9E3-03A047D89056}"/>
                </a:ext>
              </a:extLst>
            </p:cNvPr>
            <p:cNvSpPr txBox="1"/>
            <p:nvPr/>
          </p:nvSpPr>
          <p:spPr>
            <a:xfrm>
              <a:off x="605423" y="1492683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25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C748030-DA7A-7B22-9D7A-9C52E45D55D7}"/>
                </a:ext>
              </a:extLst>
            </p:cNvPr>
            <p:cNvSpPr txBox="1"/>
            <p:nvPr/>
          </p:nvSpPr>
          <p:spPr>
            <a:xfrm>
              <a:off x="605424" y="1659696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15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C6BB88BC-C2DF-43EC-22B7-C9DE431F08AA}"/>
                </a:ext>
              </a:extLst>
            </p:cNvPr>
            <p:cNvSpPr txBox="1"/>
            <p:nvPr/>
          </p:nvSpPr>
          <p:spPr>
            <a:xfrm>
              <a:off x="594985" y="1858024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10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405255E9-7893-EC2F-E0B1-D5972F0BABB6}"/>
                </a:ext>
              </a:extLst>
            </p:cNvPr>
            <p:cNvSpPr txBox="1"/>
            <p:nvPr/>
          </p:nvSpPr>
          <p:spPr>
            <a:xfrm>
              <a:off x="657616" y="2035475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75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4AADACB-0790-65A8-82D6-08E13F48D2BB}"/>
                </a:ext>
              </a:extLst>
            </p:cNvPr>
            <p:cNvSpPr txBox="1"/>
            <p:nvPr/>
          </p:nvSpPr>
          <p:spPr>
            <a:xfrm>
              <a:off x="657615" y="2463447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50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79D2CFB-802D-5BDD-013F-96A66B378942}"/>
                </a:ext>
              </a:extLst>
            </p:cNvPr>
            <p:cNvSpPr txBox="1"/>
            <p:nvPr/>
          </p:nvSpPr>
          <p:spPr>
            <a:xfrm>
              <a:off x="657615" y="2787036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37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F8204EC-7B96-1F3D-8DA9-603DD39ADA2D}"/>
                </a:ext>
              </a:extLst>
            </p:cNvPr>
            <p:cNvSpPr txBox="1"/>
            <p:nvPr/>
          </p:nvSpPr>
          <p:spPr>
            <a:xfrm>
              <a:off x="657615" y="3225446"/>
              <a:ext cx="814189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25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9252C268-322A-312E-9F1F-E46701E89C3A}"/>
                </a:ext>
              </a:extLst>
            </p:cNvPr>
            <p:cNvSpPr txBox="1"/>
            <p:nvPr/>
          </p:nvSpPr>
          <p:spPr>
            <a:xfrm>
              <a:off x="668052" y="3413335"/>
              <a:ext cx="814189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2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E1C308DB-C4E1-4ACE-B301-0B8DC2EE0466}"/>
              </a:ext>
            </a:extLst>
          </p:cNvPr>
          <p:cNvGrpSpPr/>
          <p:nvPr/>
        </p:nvGrpSpPr>
        <p:grpSpPr>
          <a:xfrm>
            <a:off x="2964492" y="1096025"/>
            <a:ext cx="2473873" cy="2194759"/>
            <a:chOff x="501040" y="3768244"/>
            <a:chExt cx="2473873" cy="2194759"/>
          </a:xfrm>
        </p:grpSpPr>
        <p:pic>
          <p:nvPicPr>
            <p:cNvPr id="62" name="Picture 61" descr="A shadow of a line on a white surface&#10;&#10;Description automatically generated">
              <a:extLst>
                <a:ext uri="{FF2B5EF4-FFF2-40B4-BE49-F238E27FC236}">
                  <a16:creationId xmlns:a16="http://schemas.microsoft.com/office/drawing/2014/main" id="{95052B38-A33C-1A54-36AA-D6EDB7568A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-253" t="17647" r="56814" b="22706"/>
            <a:stretch/>
          </p:blipFill>
          <p:spPr>
            <a:xfrm>
              <a:off x="970765" y="3769472"/>
              <a:ext cx="2004148" cy="2193531"/>
            </a:xfrm>
            <a:prstGeom prst="rect">
              <a:avLst/>
            </a:prstGeom>
          </p:spPr>
        </p:pic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D150C37E-6685-7ECD-813C-EE196E2B9582}"/>
                </a:ext>
              </a:extLst>
            </p:cNvPr>
            <p:cNvSpPr txBox="1"/>
            <p:nvPr/>
          </p:nvSpPr>
          <p:spPr>
            <a:xfrm>
              <a:off x="511477" y="3768244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25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0C27CE30-F4E3-5E9D-BEC0-126B8CDD99A2}"/>
                </a:ext>
              </a:extLst>
            </p:cNvPr>
            <p:cNvSpPr txBox="1"/>
            <p:nvPr/>
          </p:nvSpPr>
          <p:spPr>
            <a:xfrm>
              <a:off x="511479" y="3935258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15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A051A47-4431-D3EA-1CB0-F28F88C6FEB0}"/>
                </a:ext>
              </a:extLst>
            </p:cNvPr>
            <p:cNvSpPr txBox="1"/>
            <p:nvPr/>
          </p:nvSpPr>
          <p:spPr>
            <a:xfrm>
              <a:off x="501040" y="4133585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10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403C8870-3028-C30D-5EED-461F84E4F0EE}"/>
                </a:ext>
              </a:extLst>
            </p:cNvPr>
            <p:cNvSpPr txBox="1"/>
            <p:nvPr/>
          </p:nvSpPr>
          <p:spPr>
            <a:xfrm>
              <a:off x="563671" y="4311036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75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ACE73F36-39A8-275F-64E9-63E6578C9968}"/>
                </a:ext>
              </a:extLst>
            </p:cNvPr>
            <p:cNvSpPr txBox="1"/>
            <p:nvPr/>
          </p:nvSpPr>
          <p:spPr>
            <a:xfrm>
              <a:off x="563669" y="4739009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50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D921635C-1912-FA85-6AE0-419D4847F92E}"/>
                </a:ext>
              </a:extLst>
            </p:cNvPr>
            <p:cNvSpPr txBox="1"/>
            <p:nvPr/>
          </p:nvSpPr>
          <p:spPr>
            <a:xfrm>
              <a:off x="563669" y="5062597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37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8379CC0F-3C00-0D76-B035-A0425518DE52}"/>
                </a:ext>
              </a:extLst>
            </p:cNvPr>
            <p:cNvSpPr txBox="1"/>
            <p:nvPr/>
          </p:nvSpPr>
          <p:spPr>
            <a:xfrm>
              <a:off x="563669" y="5501007"/>
              <a:ext cx="814189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25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38D9DEE5-EB5D-77D0-9248-6C9E53978BEC}"/>
                </a:ext>
              </a:extLst>
            </p:cNvPr>
            <p:cNvSpPr txBox="1"/>
            <p:nvPr/>
          </p:nvSpPr>
          <p:spPr>
            <a:xfrm>
              <a:off x="574106" y="5688896"/>
              <a:ext cx="814189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2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</p:grpSp>
      <p:sp>
        <p:nvSpPr>
          <p:cNvPr id="72" name="TextBox 71">
            <a:extLst>
              <a:ext uri="{FF2B5EF4-FFF2-40B4-BE49-F238E27FC236}">
                <a16:creationId xmlns:a16="http://schemas.microsoft.com/office/drawing/2014/main" id="{CDA2A51F-6085-F182-8797-9DB9AB5F9ACE}"/>
              </a:ext>
            </a:extLst>
          </p:cNvPr>
          <p:cNvSpPr txBox="1"/>
          <p:nvPr/>
        </p:nvSpPr>
        <p:spPr>
          <a:xfrm>
            <a:off x="1388302" y="1"/>
            <a:ext cx="1273479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NF1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8603DED3-7087-0451-090F-6F6444BB7799}"/>
              </a:ext>
            </a:extLst>
          </p:cNvPr>
          <p:cNvSpPr txBox="1"/>
          <p:nvPr/>
        </p:nvSpPr>
        <p:spPr>
          <a:xfrm>
            <a:off x="4248410" y="-20876"/>
            <a:ext cx="1273479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B-Actin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6B2D99B3-B48E-8943-3D7E-16D022A90C1D}"/>
              </a:ext>
            </a:extLst>
          </p:cNvPr>
          <p:cNvGrpSpPr/>
          <p:nvPr/>
        </p:nvGrpSpPr>
        <p:grpSpPr>
          <a:xfrm>
            <a:off x="6372239" y="85215"/>
            <a:ext cx="2800600" cy="3160934"/>
            <a:chOff x="6668573" y="487381"/>
            <a:chExt cx="2800600" cy="3160934"/>
          </a:xfrm>
        </p:grpSpPr>
        <p:pic>
          <p:nvPicPr>
            <p:cNvPr id="75" name="Picture 74" descr="A close-up of a test&#10;&#10;Description automatically generated">
              <a:extLst>
                <a:ext uri="{FF2B5EF4-FFF2-40B4-BE49-F238E27FC236}">
                  <a16:creationId xmlns:a16="http://schemas.microsoft.com/office/drawing/2014/main" id="{739B33CC-15E0-B1BB-398A-E0D0F4A518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84" t="13155" r="56349" b="25817"/>
            <a:stretch/>
          </p:blipFill>
          <p:spPr>
            <a:xfrm>
              <a:off x="7194690" y="1403036"/>
              <a:ext cx="2033678" cy="2245279"/>
            </a:xfrm>
            <a:prstGeom prst="rect">
              <a:avLst/>
            </a:prstGeom>
          </p:spPr>
        </p:pic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30209BE1-26DC-6DAA-7DF6-B88391E53A64}"/>
                </a:ext>
              </a:extLst>
            </p:cNvPr>
            <p:cNvSpPr txBox="1"/>
            <p:nvPr/>
          </p:nvSpPr>
          <p:spPr>
            <a:xfrm rot="18720000">
              <a:off x="7619442" y="927026"/>
              <a:ext cx="10234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R1276Q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4761A713-B1D5-CD5D-A98E-7E21FC735094}"/>
                </a:ext>
              </a:extLst>
            </p:cNvPr>
            <p:cNvSpPr txBox="1"/>
            <p:nvPr/>
          </p:nvSpPr>
          <p:spPr>
            <a:xfrm rot="18827009">
              <a:off x="7290010" y="928840"/>
              <a:ext cx="10234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Knock Out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C4CB6E82-509C-31FA-7F46-5C695CA91C7B}"/>
                </a:ext>
              </a:extLst>
            </p:cNvPr>
            <p:cNvSpPr txBox="1"/>
            <p:nvPr/>
          </p:nvSpPr>
          <p:spPr>
            <a:xfrm rot="18966357">
              <a:off x="7963598" y="941580"/>
              <a:ext cx="10234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HEK 293 +/+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78B25889-41AB-2A54-6872-D35F6CBD4E32}"/>
                </a:ext>
              </a:extLst>
            </p:cNvPr>
            <p:cNvSpPr txBox="1"/>
            <p:nvPr/>
          </p:nvSpPr>
          <p:spPr>
            <a:xfrm rot="18821298">
              <a:off x="8216088" y="917789"/>
              <a:ext cx="11124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Empty Vector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BED12F68-A54E-CFBA-ACDD-C83DEC93C8FE}"/>
                </a:ext>
              </a:extLst>
            </p:cNvPr>
            <p:cNvSpPr txBox="1"/>
            <p:nvPr/>
          </p:nvSpPr>
          <p:spPr>
            <a:xfrm rot="18821298">
              <a:off x="8479386" y="905109"/>
              <a:ext cx="11124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Wild Type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5C2646F3-AE38-A546-F8DF-D545266BD8AE}"/>
                </a:ext>
              </a:extLst>
            </p:cNvPr>
            <p:cNvSpPr txBox="1"/>
            <p:nvPr/>
          </p:nvSpPr>
          <p:spPr>
            <a:xfrm rot="18821298">
              <a:off x="8774446" y="923222"/>
              <a:ext cx="11124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Del Exon 24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754D05C8-1CC4-31B1-6279-2B22092D1E44}"/>
                </a:ext>
              </a:extLst>
            </p:cNvPr>
            <p:cNvSpPr txBox="1"/>
            <p:nvPr/>
          </p:nvSpPr>
          <p:spPr>
            <a:xfrm>
              <a:off x="6679011" y="1403036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25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EC0F723F-6F1C-7E6B-A87F-52C3147637E5}"/>
                </a:ext>
              </a:extLst>
            </p:cNvPr>
            <p:cNvSpPr txBox="1"/>
            <p:nvPr/>
          </p:nvSpPr>
          <p:spPr>
            <a:xfrm>
              <a:off x="6679012" y="1592460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15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ECA59A32-6959-0B87-B5B5-2FF3DCEC2934}"/>
                </a:ext>
              </a:extLst>
            </p:cNvPr>
            <p:cNvSpPr txBox="1"/>
            <p:nvPr/>
          </p:nvSpPr>
          <p:spPr>
            <a:xfrm>
              <a:off x="6668573" y="1824406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10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86468432-3303-19BD-120D-E6D8CB97E923}"/>
                </a:ext>
              </a:extLst>
            </p:cNvPr>
            <p:cNvSpPr txBox="1"/>
            <p:nvPr/>
          </p:nvSpPr>
          <p:spPr>
            <a:xfrm>
              <a:off x="6731204" y="2013063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75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F453B3F2-BBDE-4345-E908-324E3BBA9E73}"/>
                </a:ext>
              </a:extLst>
            </p:cNvPr>
            <p:cNvSpPr txBox="1"/>
            <p:nvPr/>
          </p:nvSpPr>
          <p:spPr>
            <a:xfrm>
              <a:off x="6731203" y="2441035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50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271F99CF-7DB2-45BE-5774-2D06652E2960}"/>
                </a:ext>
              </a:extLst>
            </p:cNvPr>
            <p:cNvSpPr txBox="1"/>
            <p:nvPr/>
          </p:nvSpPr>
          <p:spPr>
            <a:xfrm>
              <a:off x="6731203" y="2820653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37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CE6050BD-515B-F7B0-C1F7-B0CE71DFC4A3}"/>
                </a:ext>
              </a:extLst>
            </p:cNvPr>
            <p:cNvSpPr txBox="1"/>
            <p:nvPr/>
          </p:nvSpPr>
          <p:spPr>
            <a:xfrm>
              <a:off x="6731203" y="3259063"/>
              <a:ext cx="814189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25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89C48299-E02F-267C-BDEE-27D5F5ECC08C}"/>
                </a:ext>
              </a:extLst>
            </p:cNvPr>
            <p:cNvSpPr txBox="1"/>
            <p:nvPr/>
          </p:nvSpPr>
          <p:spPr>
            <a:xfrm>
              <a:off x="6741640" y="3379717"/>
              <a:ext cx="814189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2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F08A8C2C-8849-C843-9975-7CEBA927BD66}"/>
              </a:ext>
            </a:extLst>
          </p:cNvPr>
          <p:cNvGrpSpPr/>
          <p:nvPr/>
        </p:nvGrpSpPr>
        <p:grpSpPr>
          <a:xfrm>
            <a:off x="9275185" y="987795"/>
            <a:ext cx="2543960" cy="2312549"/>
            <a:chOff x="6724602" y="3644212"/>
            <a:chExt cx="2543960" cy="2312549"/>
          </a:xfrm>
        </p:grpSpPr>
        <p:pic>
          <p:nvPicPr>
            <p:cNvPr id="76" name="Picture 75" descr="A black and white photo of a line&#10;&#10;Description automatically generated">
              <a:extLst>
                <a:ext uri="{FF2B5EF4-FFF2-40B4-BE49-F238E27FC236}">
                  <a16:creationId xmlns:a16="http://schemas.microsoft.com/office/drawing/2014/main" id="{67329567-DD28-00FC-7099-12C5123E34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-1094" t="6011" r="56720" b="36514"/>
            <a:stretch/>
          </p:blipFill>
          <p:spPr>
            <a:xfrm>
              <a:off x="7205127" y="3644212"/>
              <a:ext cx="2063435" cy="2225312"/>
            </a:xfrm>
            <a:prstGeom prst="rect">
              <a:avLst/>
            </a:prstGeom>
          </p:spPr>
        </p:pic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D55704D3-B8BB-6B74-437E-D31F19C741AF}"/>
                </a:ext>
              </a:extLst>
            </p:cNvPr>
            <p:cNvSpPr txBox="1"/>
            <p:nvPr/>
          </p:nvSpPr>
          <p:spPr>
            <a:xfrm>
              <a:off x="6735040" y="3644212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25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68E455C9-BEA2-B0E7-887F-65A4B460DAFE}"/>
                </a:ext>
              </a:extLst>
            </p:cNvPr>
            <p:cNvSpPr txBox="1"/>
            <p:nvPr/>
          </p:nvSpPr>
          <p:spPr>
            <a:xfrm>
              <a:off x="6735041" y="3833636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15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08BA8D40-CABC-5C61-C821-7DBCEE870445}"/>
                </a:ext>
              </a:extLst>
            </p:cNvPr>
            <p:cNvSpPr txBox="1"/>
            <p:nvPr/>
          </p:nvSpPr>
          <p:spPr>
            <a:xfrm>
              <a:off x="6724602" y="4087994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10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F8610F81-D02A-8C72-8FAB-78EC19AFD8F2}"/>
                </a:ext>
              </a:extLst>
            </p:cNvPr>
            <p:cNvSpPr txBox="1"/>
            <p:nvPr/>
          </p:nvSpPr>
          <p:spPr>
            <a:xfrm>
              <a:off x="6787233" y="4287857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75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72C34B43-4EE0-BCFF-058D-4A1DED27220C}"/>
                </a:ext>
              </a:extLst>
            </p:cNvPr>
            <p:cNvSpPr txBox="1"/>
            <p:nvPr/>
          </p:nvSpPr>
          <p:spPr>
            <a:xfrm>
              <a:off x="6787232" y="4727035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50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A9304563-A7D4-C12A-63DE-55480A0AA6AE}"/>
                </a:ext>
              </a:extLst>
            </p:cNvPr>
            <p:cNvSpPr txBox="1"/>
            <p:nvPr/>
          </p:nvSpPr>
          <p:spPr>
            <a:xfrm>
              <a:off x="6787232" y="5095447"/>
              <a:ext cx="709806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37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BCDB89A3-0292-BCD7-59C1-3456179333AF}"/>
                </a:ext>
              </a:extLst>
            </p:cNvPr>
            <p:cNvSpPr txBox="1"/>
            <p:nvPr/>
          </p:nvSpPr>
          <p:spPr>
            <a:xfrm>
              <a:off x="6787232" y="5601092"/>
              <a:ext cx="814189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25 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9078F5C6-F129-4D69-E9EF-CBC62A68CD10}"/>
                </a:ext>
              </a:extLst>
            </p:cNvPr>
            <p:cNvSpPr txBox="1"/>
            <p:nvPr/>
          </p:nvSpPr>
          <p:spPr>
            <a:xfrm>
              <a:off x="6797669" y="5710540"/>
              <a:ext cx="814189" cy="246221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/>
                <a:t>20 </a:t>
              </a:r>
              <a:r>
                <a:rPr lang="en-US" sz="1000" dirty="0" err="1"/>
                <a:t>kD</a:t>
              </a:r>
              <a:r>
                <a:rPr lang="en-US" sz="1000" dirty="0"/>
                <a:t>-</a:t>
              </a:r>
              <a:endParaRPr lang="en-US" dirty="0" err="1"/>
            </a:p>
          </p:txBody>
        </p:sp>
      </p:grpSp>
      <p:sp>
        <p:nvSpPr>
          <p:cNvPr id="108" name="TextBox 107">
            <a:extLst>
              <a:ext uri="{FF2B5EF4-FFF2-40B4-BE49-F238E27FC236}">
                <a16:creationId xmlns:a16="http://schemas.microsoft.com/office/drawing/2014/main" id="{0D47AC65-AC38-D47A-31F8-F6BD948C53EF}"/>
              </a:ext>
            </a:extLst>
          </p:cNvPr>
          <p:cNvSpPr txBox="1"/>
          <p:nvPr/>
        </p:nvSpPr>
        <p:spPr>
          <a:xfrm>
            <a:off x="7511035" y="20408"/>
            <a:ext cx="1273479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 err="1"/>
              <a:t>pERK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ECD77491-7981-C7AC-FB54-11E8E6E682D8}"/>
              </a:ext>
            </a:extLst>
          </p:cNvPr>
          <p:cNvSpPr txBox="1"/>
          <p:nvPr/>
        </p:nvSpPr>
        <p:spPr>
          <a:xfrm>
            <a:off x="10637646" y="17926"/>
            <a:ext cx="1273479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dirty="0"/>
              <a:t>ERK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26FB29C-5F83-A874-AC0F-3DA608BF0061}"/>
              </a:ext>
            </a:extLst>
          </p:cNvPr>
          <p:cNvSpPr txBox="1"/>
          <p:nvPr/>
        </p:nvSpPr>
        <p:spPr>
          <a:xfrm rot="18720000">
            <a:off x="3955578" y="572122"/>
            <a:ext cx="10234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R1276Q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259B21-6B86-A418-CE82-D7765B80EC0D}"/>
              </a:ext>
            </a:extLst>
          </p:cNvPr>
          <p:cNvSpPr txBox="1"/>
          <p:nvPr/>
        </p:nvSpPr>
        <p:spPr>
          <a:xfrm rot="18827009">
            <a:off x="3626146" y="573935"/>
            <a:ext cx="10234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Knock Ou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A9CAD71-B2BC-0261-FD59-7A727EBB92E6}"/>
              </a:ext>
            </a:extLst>
          </p:cNvPr>
          <p:cNvSpPr txBox="1"/>
          <p:nvPr/>
        </p:nvSpPr>
        <p:spPr>
          <a:xfrm rot="18966357">
            <a:off x="4257980" y="586676"/>
            <a:ext cx="10234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HEK 293 +/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6F21E5D-3BFA-2BC1-BF06-EF1895D78B19}"/>
              </a:ext>
            </a:extLst>
          </p:cNvPr>
          <p:cNvSpPr txBox="1"/>
          <p:nvPr/>
        </p:nvSpPr>
        <p:spPr>
          <a:xfrm rot="18821298">
            <a:off x="4552224" y="562885"/>
            <a:ext cx="1112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Empty Vecto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ED3A9C4-9702-B5A1-DADF-F6E47D2DEE19}"/>
              </a:ext>
            </a:extLst>
          </p:cNvPr>
          <p:cNvSpPr txBox="1"/>
          <p:nvPr/>
        </p:nvSpPr>
        <p:spPr>
          <a:xfrm rot="18821298">
            <a:off x="4815522" y="550205"/>
            <a:ext cx="1112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Wild Typ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A0128B4-6111-97BD-12ED-788453576DC1}"/>
              </a:ext>
            </a:extLst>
          </p:cNvPr>
          <p:cNvSpPr txBox="1"/>
          <p:nvPr/>
        </p:nvSpPr>
        <p:spPr>
          <a:xfrm rot="18821298">
            <a:off x="5110582" y="568317"/>
            <a:ext cx="1112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Del Exon 2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37A8AD5-E6B5-F33F-8C12-D45AD29E76C1}"/>
              </a:ext>
            </a:extLst>
          </p:cNvPr>
          <p:cNvSpPr txBox="1"/>
          <p:nvPr/>
        </p:nvSpPr>
        <p:spPr>
          <a:xfrm>
            <a:off x="783166" y="3185583"/>
            <a:ext cx="2095500" cy="24622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000" dirty="0"/>
              <a:t>0: 28553: 4551: 0: 23486: 1247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C3B630D-E1C7-EED6-B493-135CEE35189B}"/>
              </a:ext>
            </a:extLst>
          </p:cNvPr>
          <p:cNvSpPr txBox="1"/>
          <p:nvPr/>
        </p:nvSpPr>
        <p:spPr>
          <a:xfrm>
            <a:off x="3545415" y="3259665"/>
            <a:ext cx="2635249" cy="2308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dirty="0"/>
              <a:t>13848: 12400: 8067: 9452: 10041: 10155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525ED92-E5D9-38F9-D7BA-B3ECE56EE84A}"/>
              </a:ext>
            </a:extLst>
          </p:cNvPr>
          <p:cNvSpPr txBox="1"/>
          <p:nvPr/>
        </p:nvSpPr>
        <p:spPr>
          <a:xfrm rot="18720000">
            <a:off x="10199744" y="466288"/>
            <a:ext cx="10234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R1276Q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5FE961D-232A-7349-B265-26ABD3D00E2D}"/>
              </a:ext>
            </a:extLst>
          </p:cNvPr>
          <p:cNvSpPr txBox="1"/>
          <p:nvPr/>
        </p:nvSpPr>
        <p:spPr>
          <a:xfrm rot="18827009">
            <a:off x="9870312" y="468101"/>
            <a:ext cx="10234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Knock Out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71D21F7-7EF0-3BE2-F3D7-1F10E511D208}"/>
              </a:ext>
            </a:extLst>
          </p:cNvPr>
          <p:cNvSpPr txBox="1"/>
          <p:nvPr/>
        </p:nvSpPr>
        <p:spPr>
          <a:xfrm rot="18966357">
            <a:off x="10502146" y="480842"/>
            <a:ext cx="10234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HEK 293 +/+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3764FA3-FD67-54DE-836A-1B59DD12265C}"/>
              </a:ext>
            </a:extLst>
          </p:cNvPr>
          <p:cNvSpPr txBox="1"/>
          <p:nvPr/>
        </p:nvSpPr>
        <p:spPr>
          <a:xfrm rot="18821298">
            <a:off x="10796390" y="457051"/>
            <a:ext cx="1112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Empty Vector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4653CEB-C6F7-C2E7-4B62-2B303CF7F080}"/>
              </a:ext>
            </a:extLst>
          </p:cNvPr>
          <p:cNvSpPr txBox="1"/>
          <p:nvPr/>
        </p:nvSpPr>
        <p:spPr>
          <a:xfrm rot="18821298">
            <a:off x="11059688" y="444371"/>
            <a:ext cx="1112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Wild Typ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F96ECD4-39F5-2458-C682-EAB195B43D7E}"/>
              </a:ext>
            </a:extLst>
          </p:cNvPr>
          <p:cNvSpPr txBox="1"/>
          <p:nvPr/>
        </p:nvSpPr>
        <p:spPr>
          <a:xfrm rot="18821298">
            <a:off x="11354748" y="462483"/>
            <a:ext cx="1112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Del Exon 24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8298710-50B5-C9BE-60BF-9C7E9C45D88E}"/>
              </a:ext>
            </a:extLst>
          </p:cNvPr>
          <p:cNvSpPr txBox="1"/>
          <p:nvPr/>
        </p:nvSpPr>
        <p:spPr>
          <a:xfrm>
            <a:off x="7006165" y="3249081"/>
            <a:ext cx="2635249" cy="2308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dirty="0"/>
              <a:t>14847: 11003: 2496: 10118: 7547: 8559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4ECAAF4-379D-A1BA-4A61-8341E19D168F}"/>
              </a:ext>
            </a:extLst>
          </p:cNvPr>
          <p:cNvSpPr txBox="1"/>
          <p:nvPr/>
        </p:nvSpPr>
        <p:spPr>
          <a:xfrm>
            <a:off x="9884831" y="3291414"/>
            <a:ext cx="2635249" cy="2308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dirty="0"/>
              <a:t>21822: 15149: 9364: 18214: 17382: 17887</a:t>
            </a:r>
          </a:p>
        </p:txBody>
      </p:sp>
    </p:spTree>
    <p:extLst>
      <p:ext uri="{BB962C8B-B14F-4D97-AF65-F5344CB8AC3E}">
        <p14:creationId xmlns:p14="http://schemas.microsoft.com/office/powerpoint/2010/main" val="3639428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64</Words>
  <Application>Microsoft Office PowerPoint</Application>
  <PresentationFormat>Widescreen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llis, Deeann</dc:creator>
  <cp:lastModifiedBy>Wallis, Deeann</cp:lastModifiedBy>
  <cp:revision>104</cp:revision>
  <dcterms:created xsi:type="dcterms:W3CDTF">2024-05-15T17:23:27Z</dcterms:created>
  <dcterms:modified xsi:type="dcterms:W3CDTF">2024-05-16T20:05:16Z</dcterms:modified>
</cp:coreProperties>
</file>